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573" r:id="rId2"/>
  </p:sldIdLst>
  <p:sldSz cx="6858000" cy="9144000" type="letter"/>
  <p:notesSz cx="7102475" cy="93884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6DFF00"/>
    <a:srgbClr val="FFFF00"/>
    <a:srgbClr val="171717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33" autoAdjust="0"/>
    <p:restoredTop sz="71953" autoAdjust="0"/>
  </p:normalViewPr>
  <p:slideViewPr>
    <p:cSldViewPr snapToGrid="0">
      <p:cViewPr varScale="1">
        <p:scale>
          <a:sx n="105" d="100"/>
          <a:sy n="105" d="100"/>
        </p:scale>
        <p:origin x="1912" y="2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39" cy="471054"/>
          </a:xfrm>
          <a:prstGeom prst="rect">
            <a:avLst/>
          </a:prstGeom>
        </p:spPr>
        <p:txBody>
          <a:bodyPr vert="horz" lIns="94221" tIns="47111" rIns="94221" bIns="4711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093" y="0"/>
            <a:ext cx="3077739" cy="471054"/>
          </a:xfrm>
          <a:prstGeom prst="rect">
            <a:avLst/>
          </a:prstGeom>
        </p:spPr>
        <p:txBody>
          <a:bodyPr vert="horz" lIns="94221" tIns="47111" rIns="94221" bIns="47111" rtlCol="0"/>
          <a:lstStyle>
            <a:lvl1pPr algn="r">
              <a:defRPr sz="1200"/>
            </a:lvl1pPr>
          </a:lstStyle>
          <a:p>
            <a:fld id="{E92D1EB7-785E-4EC2-902A-935C806FE68F}" type="datetimeFigureOut">
              <a:rPr lang="en-US" smtClean="0"/>
              <a:t>4/7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73163"/>
            <a:ext cx="2378075" cy="31686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221" tIns="47111" rIns="94221" bIns="4711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248" y="4518203"/>
            <a:ext cx="5681980" cy="3696713"/>
          </a:xfrm>
          <a:prstGeom prst="rect">
            <a:avLst/>
          </a:prstGeom>
        </p:spPr>
        <p:txBody>
          <a:bodyPr vert="horz" lIns="94221" tIns="47111" rIns="94221" bIns="4711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917423"/>
            <a:ext cx="3077739" cy="471053"/>
          </a:xfrm>
          <a:prstGeom prst="rect">
            <a:avLst/>
          </a:prstGeom>
        </p:spPr>
        <p:txBody>
          <a:bodyPr vert="horz" lIns="94221" tIns="47111" rIns="94221" bIns="4711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093" y="8917423"/>
            <a:ext cx="3077739" cy="471053"/>
          </a:xfrm>
          <a:prstGeom prst="rect">
            <a:avLst/>
          </a:prstGeom>
        </p:spPr>
        <p:txBody>
          <a:bodyPr vert="horz" lIns="94221" tIns="47111" rIns="94221" bIns="47111" rtlCol="0" anchor="b"/>
          <a:lstStyle>
            <a:lvl1pPr algn="r">
              <a:defRPr sz="1200"/>
            </a:lvl1pPr>
          </a:lstStyle>
          <a:p>
            <a:fld id="{122F76DF-B0D4-4C7B-A882-555C14374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1397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0" dirty="0">
                <a:solidFill>
                  <a:srgbClr val="734126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ree-dimensional segmentation using Amira software. Protocol for generating surfaces and representative ortho slices of mitochondria-ER and MERCS, creating a video maker option for better visualization using Amira protocols</a:t>
            </a:r>
            <a:r>
              <a:rPr lang="en-US" dirty="0">
                <a:effectLst/>
              </a:rPr>
              <a:t> </a:t>
            </a:r>
            <a:endParaRPr lang="en-US" sz="1200" b="1" i="0" dirty="0">
              <a:solidFill>
                <a:srgbClr val="734126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1" i="0" dirty="0">
              <a:solidFill>
                <a:srgbClr val="734126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2F76DF-B0D4-4C7B-A882-555C143747E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8295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615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4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3631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654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604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440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427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038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5632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008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536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663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g"/><Relationship Id="rId11" Type="http://schemas.openxmlformats.org/officeDocument/2006/relationships/image" Target="../media/image8.png"/><Relationship Id="rId5" Type="http://schemas.openxmlformats.org/officeDocument/2006/relationships/image" Target="../media/image3.png"/><Relationship Id="rId10" Type="http://schemas.microsoft.com/office/2007/relationships/hdphoto" Target="../media/hdphoto1.wdp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74DA2B71-E9FF-6652-89BC-1FD51A5E36C4}"/>
              </a:ext>
            </a:extLst>
          </p:cNvPr>
          <p:cNvGrpSpPr>
            <a:grpSpLocks noChangeAspect="1"/>
          </p:cNvGrpSpPr>
          <p:nvPr/>
        </p:nvGrpSpPr>
        <p:grpSpPr>
          <a:xfrm>
            <a:off x="-497603" y="553196"/>
            <a:ext cx="7853205" cy="5802988"/>
            <a:chOff x="-27203" y="363096"/>
            <a:chExt cx="6349936" cy="4444955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DFFC183C-B42B-8F26-3749-1069731BCFAA}"/>
                </a:ext>
              </a:extLst>
            </p:cNvPr>
            <p:cNvGrpSpPr/>
            <p:nvPr/>
          </p:nvGrpSpPr>
          <p:grpSpPr>
            <a:xfrm>
              <a:off x="-27203" y="363096"/>
              <a:ext cx="6349936" cy="4444955"/>
              <a:chOff x="-145401" y="5442616"/>
              <a:chExt cx="6349936" cy="4444955"/>
            </a:xfrm>
          </p:grpSpPr>
          <p:pic>
            <p:nvPicPr>
              <p:cNvPr id="16" name="Content Placeholder 9" descr="A picture containing background pattern&#10;&#10;Description automatically generated">
                <a:extLst>
                  <a:ext uri="{FF2B5EF4-FFF2-40B4-BE49-F238E27FC236}">
                    <a16:creationId xmlns:a16="http://schemas.microsoft.com/office/drawing/2014/main" id="{D5AA6D36-C6A1-3F82-7A36-30B1ED17E06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-145401" y="5442616"/>
                <a:ext cx="6349936" cy="4444955"/>
              </a:xfrm>
              <a:prstGeom prst="rect">
                <a:avLst/>
              </a:prstGeom>
            </p:spPr>
          </p:pic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BAAD0AD3-2F99-63C8-93FA-A003F1002D4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139" r="46283" b="66495"/>
              <a:stretch/>
            </p:blipFill>
            <p:spPr bwMode="auto">
              <a:xfrm>
                <a:off x="457921" y="6302024"/>
                <a:ext cx="1238622" cy="1216152"/>
              </a:xfrm>
              <a:prstGeom prst="rect">
                <a:avLst/>
              </a:prstGeom>
              <a:noFill/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18" name="Picture 17" descr="A picture containing text, picture frame&#10;&#10;Description automatically generated">
                <a:extLst>
                  <a:ext uri="{FF2B5EF4-FFF2-40B4-BE49-F238E27FC236}">
                    <a16:creationId xmlns:a16="http://schemas.microsoft.com/office/drawing/2014/main" id="{3928E7F9-011D-F7D7-255D-202ACB08B62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62" t="16656"/>
              <a:stretch/>
            </p:blipFill>
            <p:spPr>
              <a:xfrm>
                <a:off x="1709044" y="6283736"/>
                <a:ext cx="1238622" cy="1234440"/>
              </a:xfrm>
              <a:prstGeom prst="rect">
                <a:avLst/>
              </a:prstGeom>
            </p:spPr>
          </p:pic>
          <p:pic>
            <p:nvPicPr>
              <p:cNvPr id="19" name="Picture 18" descr="A picture containing airplane, aircraft, transport&#10;&#10;Description automatically generated">
                <a:extLst>
                  <a:ext uri="{FF2B5EF4-FFF2-40B4-BE49-F238E27FC236}">
                    <a16:creationId xmlns:a16="http://schemas.microsoft.com/office/drawing/2014/main" id="{9E0C3D28-68D2-A4C8-BD96-F5D34590DE7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453" t="25812" r="21588" b="29978"/>
              <a:stretch/>
            </p:blipFill>
            <p:spPr>
              <a:xfrm>
                <a:off x="4237485" y="6283736"/>
                <a:ext cx="1238621" cy="1232676"/>
              </a:xfrm>
              <a:prstGeom prst="rect">
                <a:avLst/>
              </a:prstGeom>
            </p:spPr>
          </p:pic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5A143979-9C2D-0DF2-3E4D-1A830D23AD8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43082" t="7083" r="46035" b="64289"/>
              <a:stretch/>
            </p:blipFill>
            <p:spPr>
              <a:xfrm>
                <a:off x="2973265" y="6285499"/>
                <a:ext cx="1238622" cy="1232677"/>
              </a:xfrm>
              <a:prstGeom prst="rect">
                <a:avLst/>
              </a:prstGeom>
            </p:spPr>
          </p:pic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F74B15B7-89FF-01F6-05B5-26033B64CFD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43169" t="10731" r="46191" b="67948"/>
              <a:stretch/>
            </p:blipFill>
            <p:spPr>
              <a:xfrm>
                <a:off x="457920" y="8345438"/>
                <a:ext cx="1238621" cy="1259306"/>
              </a:xfrm>
              <a:prstGeom prst="rect">
                <a:avLst/>
              </a:prstGeom>
            </p:spPr>
          </p:pic>
          <p:pic>
            <p:nvPicPr>
              <p:cNvPr id="22" name="Picture 21" descr="Chart&#10;&#10;Description automatically generated">
                <a:extLst>
                  <a:ext uri="{FF2B5EF4-FFF2-40B4-BE49-F238E27FC236}">
                    <a16:creationId xmlns:a16="http://schemas.microsoft.com/office/drawing/2014/main" id="{3BB788F6-7FFF-2613-B5AF-89541CA03A9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ackgroundRemoval t="12791" b="90310" l="9797" r="88175">
                            <a14:foregroundMark x1="26047" y1="50424" x2="35540" y2="49010"/>
                            <a14:foregroundMark x1="35540" y1="49010" x2="38656" y2="54668"/>
                            <a14:foregroundMark x1="38656" y1="54668" x2="33746" y2="53025"/>
                            <a14:foregroundMark x1="29939" y1="50353" x2="33057" y2="47808"/>
                            <a14:foregroundMark x1="33057" y1="47808" x2="37926" y2="49788"/>
                            <a14:foregroundMark x1="37926" y1="49788" x2="42162" y2="53536"/>
                            <a14:foregroundMark x1="42162" y1="53536" x2="33009" y2="47100"/>
                            <a14:foregroundMark x1="33009" y1="47100" x2="31500" y2="47949"/>
                            <a14:backgroundMark x1="43038" y1="53395" x2="40214" y2="47737"/>
                            <a14:backgroundMark x1="40214" y1="47737" x2="35297" y2="45191"/>
                            <a14:backgroundMark x1="35297" y1="45191" x2="24976" y2="45898"/>
                            <a14:backgroundMark x1="24976" y1="45898" x2="23272" y2="39321"/>
                            <a14:backgroundMark x1="23272" y1="39321" x2="24830" y2="32107"/>
                            <a14:backgroundMark x1="24830" y1="32107" x2="30526" y2="26238"/>
                            <a14:backgroundMark x1="30526" y1="26238" x2="41918" y2="23762"/>
                            <a14:backgroundMark x1="41918" y1="23762" x2="47468" y2="23975"/>
                            <a14:backgroundMark x1="47468" y1="23975" x2="59007" y2="34512"/>
                            <a14:backgroundMark x1="59007" y1="34512" x2="62123" y2="41584"/>
                            <a14:backgroundMark x1="62123" y1="41584" x2="62123" y2="48586"/>
                            <a14:backgroundMark x1="62123" y1="48586" x2="50049" y2="52263"/>
                            <a14:backgroundMark x1="50049" y1="52263" x2="41967" y2="51627"/>
                            <a14:backgroundMark x1="34615" y1="54455" x2="30282" y2="51414"/>
                            <a14:backgroundMark x1="30282" y1="51414" x2="28530" y2="53536"/>
                            <a14:backgroundMark x1="5550" y1="59123" x2="5550" y2="59123"/>
                          </a14:backgroundRemoval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242" t="45228" r="37199" b="31830"/>
              <a:stretch/>
            </p:blipFill>
            <p:spPr>
              <a:xfrm>
                <a:off x="3029567" y="8359297"/>
                <a:ext cx="1238622" cy="1245447"/>
              </a:xfrm>
              <a:prstGeom prst="rect">
                <a:avLst/>
              </a:prstGeom>
              <a:solidFill>
                <a:schemeClr val="bg2">
                  <a:lumMod val="90000"/>
                </a:schemeClr>
              </a:solidFill>
              <a:ln w="6350">
                <a:solidFill>
                  <a:schemeClr val="tx1"/>
                </a:solidFill>
              </a:ln>
            </p:spPr>
          </p:pic>
          <p:pic>
            <p:nvPicPr>
              <p:cNvPr id="23" name="Picture 22">
                <a:extLst>
                  <a:ext uri="{FF2B5EF4-FFF2-40B4-BE49-F238E27FC236}">
                    <a16:creationId xmlns:a16="http://schemas.microsoft.com/office/drawing/2014/main" id="{D152F364-E07E-7062-C229-BC43BA2F6DA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62217" t="34930" r="19718" b="37578"/>
              <a:stretch/>
            </p:blipFill>
            <p:spPr>
              <a:xfrm>
                <a:off x="4237485" y="8370243"/>
                <a:ext cx="1238621" cy="1245447"/>
              </a:xfrm>
              <a:prstGeom prst="rect">
                <a:avLst/>
              </a:prstGeom>
            </p:spPr>
          </p:pic>
        </p:grpSp>
        <p:pic>
          <p:nvPicPr>
            <p:cNvPr id="6" name="Picture 5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D0EFBD1E-2519-0DE7-1C73-3BEB7D1F62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786" t="24725" r="23369" b="22001"/>
            <a:stretch/>
          </p:blipFill>
          <p:spPr>
            <a:xfrm flipH="1">
              <a:off x="1827242" y="3279720"/>
              <a:ext cx="1320523" cy="1243684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1A8800A-B282-1ACB-D087-6E9779CFBC74}"/>
                </a:ext>
              </a:extLst>
            </p:cNvPr>
            <p:cNvSpPr txBox="1"/>
            <p:nvPr/>
          </p:nvSpPr>
          <p:spPr>
            <a:xfrm>
              <a:off x="507595" y="846051"/>
              <a:ext cx="13196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eneration of ortho slices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05FA019-EDD4-0CC6-FAB0-6E2B59CD3DDE}"/>
                </a:ext>
              </a:extLst>
            </p:cNvPr>
            <p:cNvSpPr txBox="1"/>
            <p:nvPr/>
          </p:nvSpPr>
          <p:spPr>
            <a:xfrm>
              <a:off x="1827679" y="853676"/>
              <a:ext cx="13196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rtho slices in AMIRA software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53DBBA3-3C61-B27C-8CF1-014C6AACF4CC}"/>
                </a:ext>
              </a:extLst>
            </p:cNvPr>
            <p:cNvSpPr txBox="1"/>
            <p:nvPr/>
          </p:nvSpPr>
          <p:spPr>
            <a:xfrm>
              <a:off x="3078882" y="914167"/>
              <a:ext cx="13196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egmentation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D96CAC7-40F3-65BF-21FF-2310ACA666E4}"/>
                </a:ext>
              </a:extLst>
            </p:cNvPr>
            <p:cNvSpPr txBox="1"/>
            <p:nvPr/>
          </p:nvSpPr>
          <p:spPr>
            <a:xfrm>
              <a:off x="4355683" y="901768"/>
              <a:ext cx="13196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endering 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7ED5D85-D45B-2B05-6656-9024E5F5E983}"/>
                </a:ext>
              </a:extLst>
            </p:cNvPr>
            <p:cNvSpPr txBox="1"/>
            <p:nvPr/>
          </p:nvSpPr>
          <p:spPr>
            <a:xfrm>
              <a:off x="576118" y="3001320"/>
              <a:ext cx="13196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aking videos 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AB73641-A895-B5B5-1BB3-DD427880080D}"/>
                </a:ext>
              </a:extLst>
            </p:cNvPr>
            <p:cNvSpPr txBox="1"/>
            <p:nvPr/>
          </p:nvSpPr>
          <p:spPr>
            <a:xfrm>
              <a:off x="1827679" y="3008171"/>
              <a:ext cx="13196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D reconstruction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5FF1444-ACA6-D9D5-5E60-73451A95E0EB}"/>
                </a:ext>
              </a:extLst>
            </p:cNvPr>
            <p:cNvSpPr txBox="1"/>
            <p:nvPr/>
          </p:nvSpPr>
          <p:spPr>
            <a:xfrm>
              <a:off x="3066740" y="2997279"/>
              <a:ext cx="14705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ERCs rendering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3D2B8370-96F8-4E53-80D1-845E7AF0871E}"/>
                </a:ext>
              </a:extLst>
            </p:cNvPr>
            <p:cNvSpPr txBox="1"/>
            <p:nvPr/>
          </p:nvSpPr>
          <p:spPr>
            <a:xfrm>
              <a:off x="4330085" y="3007040"/>
              <a:ext cx="14705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ERCs quantification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748474DA-2A63-6365-6DD7-E4A0F3BC616E}"/>
              </a:ext>
            </a:extLst>
          </p:cNvPr>
          <p:cNvSpPr txBox="1"/>
          <p:nvPr/>
        </p:nvSpPr>
        <p:spPr>
          <a:xfrm>
            <a:off x="304800" y="268224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B5A8DDC-D154-BB5A-4B06-3BD82229014E}"/>
              </a:ext>
            </a:extLst>
          </p:cNvPr>
          <p:cNvSpPr txBox="1"/>
          <p:nvPr/>
        </p:nvSpPr>
        <p:spPr>
          <a:xfrm>
            <a:off x="163802" y="6256002"/>
            <a:ext cx="639113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0" dirty="0">
                <a:solidFill>
                  <a:srgbClr val="734126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hree-dimensional segmentation using Amira software. Protocol for generating surfaces and representative ortho slices of mitochondria-ER and MERCS, creating a video maker option for better visualization using Amira protocols</a:t>
            </a:r>
            <a:r>
              <a:rPr lang="en-US" sz="1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400" b="1" i="0" dirty="0">
              <a:solidFill>
                <a:srgbClr val="734126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30648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552</TotalTime>
  <Words>88</Words>
  <Application>Microsoft Macintosh PowerPoint</Application>
  <PresentationFormat>Letter Paper (8.5x11 in)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es, Jessica D.</dc:creator>
  <cp:lastModifiedBy>Trushina, Eugenia, Ph.D.</cp:lastModifiedBy>
  <cp:revision>697</cp:revision>
  <cp:lastPrinted>2022-06-28T14:24:17Z</cp:lastPrinted>
  <dcterms:created xsi:type="dcterms:W3CDTF">2022-03-01T14:24:29Z</dcterms:created>
  <dcterms:modified xsi:type="dcterms:W3CDTF">2023-04-07T16:13:58Z</dcterms:modified>
</cp:coreProperties>
</file>